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335713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E8E949-C85E-4801-94A6-D7C46C45890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17520" y="2311200"/>
            <a:ext cx="57024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17520" y="5725800"/>
            <a:ext cx="57024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5573D2-E180-41BA-BC78-71DFA3DC5BC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17520" y="23112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239640" y="23112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17520" y="57258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239640" y="57258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5FFF02-2BEF-4658-ADF1-E51112A6D68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17520" y="2311200"/>
            <a:ext cx="18360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245680" y="2311200"/>
            <a:ext cx="18360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173840" y="2311200"/>
            <a:ext cx="18360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17520" y="5725800"/>
            <a:ext cx="18360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245680" y="5725800"/>
            <a:ext cx="18360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173840" y="5725800"/>
            <a:ext cx="18360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370022-0AC6-4C64-B04C-BFE8E378355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17520" y="2311200"/>
            <a:ext cx="57024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52C0F7-B3B3-4909-990D-1C333EF8B90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17520" y="2311200"/>
            <a:ext cx="57024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0F1BE7-F78A-4B5F-96A4-A91231CBC90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17520" y="2311200"/>
            <a:ext cx="278244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239640" y="2311200"/>
            <a:ext cx="278244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6371A7-F844-462A-9265-D7839598D2E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B80840-E026-4D39-A4FF-AC624D2CDE0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17520" y="396360"/>
            <a:ext cx="57024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2E5099-18EB-47E6-B7C4-0E140D8651C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17520" y="23112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239640" y="2311200"/>
            <a:ext cx="278244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17520" y="57258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BE3852-918B-41DF-80D7-5BC5EBF5AFD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17520" y="2311200"/>
            <a:ext cx="278244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239640" y="23112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239640" y="57258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BD1CA4-85A8-48BD-82ED-39D60B1C1D2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17520" y="23112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239640" y="23112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17520" y="5725800"/>
            <a:ext cx="57024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DE5468-7BBC-4276-AC7C-7D10308D327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 Unicode MS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17520" y="2311200"/>
            <a:ext cx="57024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 Unicode MS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 Unicode MS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 Unicode MS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 Unicode MS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 Unicode MS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 Unicode MS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 Unicode MS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17160" y="9182160"/>
            <a:ext cx="14778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Arial Unicode MS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Arial Unicode MS"/>
                <a:ea typeface="Arial Unicode MS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165400" y="9182160"/>
            <a:ext cx="200664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541760" y="9182160"/>
            <a:ext cx="147816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Arial Unicode MS"/>
                <a:ea typeface="Arial Unicode MS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DC9DE7A-7088-43BE-8E83-8CBB09B2C05A}" type="slidenum">
              <a:rPr b="0" lang="ja-JP" sz="1200" spc="-1" strike="noStrike">
                <a:solidFill>
                  <a:srgbClr val="898989"/>
                </a:solidFill>
                <a:latin typeface="Arial Unicode MS"/>
                <a:ea typeface="Arial Unicode MS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グラフ 1" descr=""/>
          <p:cNvPicPr/>
          <p:nvPr/>
        </p:nvPicPr>
        <p:blipFill>
          <a:blip r:embed="rId1"/>
          <a:stretch/>
        </p:blipFill>
        <p:spPr>
          <a:xfrm>
            <a:off x="426960" y="414360"/>
            <a:ext cx="3608640" cy="2882880"/>
          </a:xfrm>
          <a:prstGeom prst="rect">
            <a:avLst/>
          </a:prstGeom>
          <a:ln w="0">
            <a:noFill/>
          </a:ln>
        </p:spPr>
      </p:pic>
      <p:sp>
        <p:nvSpPr>
          <p:cNvPr id="42" name="テキスト ボックス 142"/>
          <p:cNvSpPr/>
          <p:nvPr/>
        </p:nvSpPr>
        <p:spPr>
          <a:xfrm>
            <a:off x="1440" y="295200"/>
            <a:ext cx="257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テキスト ボックス 142"/>
          <p:cNvSpPr/>
          <p:nvPr/>
        </p:nvSpPr>
        <p:spPr>
          <a:xfrm>
            <a:off x="-360" y="3475080"/>
            <a:ext cx="26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テキスト ボックス 141"/>
          <p:cNvSpPr/>
          <p:nvPr/>
        </p:nvSpPr>
        <p:spPr>
          <a:xfrm>
            <a:off x="-25560" y="0"/>
            <a:ext cx="1767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Supplementary Figure S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テキスト ボックス 142"/>
          <p:cNvSpPr/>
          <p:nvPr/>
        </p:nvSpPr>
        <p:spPr>
          <a:xfrm>
            <a:off x="6840" y="6608880"/>
            <a:ext cx="24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グラフ 10" descr=""/>
          <p:cNvPicPr/>
          <p:nvPr/>
        </p:nvPicPr>
        <p:blipFill>
          <a:blip r:embed="rId2"/>
          <a:stretch/>
        </p:blipFill>
        <p:spPr>
          <a:xfrm>
            <a:off x="426960" y="6821640"/>
            <a:ext cx="3608640" cy="2889000"/>
          </a:xfrm>
          <a:prstGeom prst="rect">
            <a:avLst/>
          </a:prstGeom>
          <a:ln w="0">
            <a:noFill/>
          </a:ln>
        </p:spPr>
      </p:pic>
      <p:sp>
        <p:nvSpPr>
          <p:cNvPr id="47" name="直線コネクタ 11"/>
          <p:cNvSpPr/>
          <p:nvPr/>
        </p:nvSpPr>
        <p:spPr>
          <a:xfrm>
            <a:off x="1125360" y="9239400"/>
            <a:ext cx="79236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テキスト ボックス 215"/>
          <p:cNvSpPr/>
          <p:nvPr/>
        </p:nvSpPr>
        <p:spPr>
          <a:xfrm>
            <a:off x="873000" y="9379080"/>
            <a:ext cx="129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Control siRN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直線コネクタ 13"/>
          <p:cNvSpPr/>
          <p:nvPr/>
        </p:nvSpPr>
        <p:spPr>
          <a:xfrm>
            <a:off x="2268360" y="9239400"/>
            <a:ext cx="147672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テキスト ボックス 216"/>
          <p:cNvSpPr/>
          <p:nvPr/>
        </p:nvSpPr>
        <p:spPr>
          <a:xfrm>
            <a:off x="2173320" y="9379080"/>
            <a:ext cx="1666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AFAP1L1 siRNA-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グラフ 15" descr=""/>
          <p:cNvPicPr/>
          <p:nvPr/>
        </p:nvPicPr>
        <p:blipFill>
          <a:blip r:embed="rId3"/>
          <a:stretch/>
        </p:blipFill>
        <p:spPr>
          <a:xfrm>
            <a:off x="426960" y="3438360"/>
            <a:ext cx="3608640" cy="2883240"/>
          </a:xfrm>
          <a:prstGeom prst="rect">
            <a:avLst/>
          </a:prstGeom>
          <a:ln w="0">
            <a:noFill/>
          </a:ln>
        </p:spPr>
      </p:pic>
      <p:sp>
        <p:nvSpPr>
          <p:cNvPr id="52" name="直線コネクタ 16"/>
          <p:cNvSpPr/>
          <p:nvPr/>
        </p:nvSpPr>
        <p:spPr>
          <a:xfrm>
            <a:off x="2268360" y="6058080"/>
            <a:ext cx="147672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テキスト ボックス 216"/>
          <p:cNvSpPr/>
          <p:nvPr/>
        </p:nvSpPr>
        <p:spPr>
          <a:xfrm>
            <a:off x="2173320" y="6097680"/>
            <a:ext cx="1666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847800"/>
                <a:tab algn="l" pos="1695600"/>
                <a:tab algn="l" pos="2543040"/>
                <a:tab algn="l" pos="3390840"/>
                <a:tab algn="l" pos="4238640"/>
                <a:tab algn="l" pos="5086440"/>
                <a:tab algn="l" pos="5934240"/>
                <a:tab algn="l" pos="6781680"/>
                <a:tab algn="l" pos="7629480"/>
                <a:tab algn="l" pos="8477280"/>
                <a:tab algn="l" pos="9325080"/>
                <a:tab algn="l" pos="10172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AFAP1L1 siRNA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テキスト ボックス 144"/>
          <p:cNvSpPr/>
          <p:nvPr/>
        </p:nvSpPr>
        <p:spPr>
          <a:xfrm rot="16200000">
            <a:off x="-203760" y="1367280"/>
            <a:ext cx="1101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Relative index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テキスト ボックス 144"/>
          <p:cNvSpPr/>
          <p:nvPr/>
        </p:nvSpPr>
        <p:spPr>
          <a:xfrm rot="16200000">
            <a:off x="-203760" y="4566240"/>
            <a:ext cx="1101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Relative index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テキスト ボックス 144"/>
          <p:cNvSpPr/>
          <p:nvPr/>
        </p:nvSpPr>
        <p:spPr>
          <a:xfrm rot="16200000">
            <a:off x="-203760" y="8022240"/>
            <a:ext cx="1101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Relative index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7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1-10T07:50:08Z</dcterms:created>
  <dc:creator>Ryo　Takahashi</dc:creator>
  <dc:description/>
  <dc:language>en-US</dc:language>
  <cp:lastModifiedBy>戸口田 淳也</cp:lastModifiedBy>
  <dcterms:modified xsi:type="dcterms:W3CDTF">2013-09-16T07:18:42Z</dcterms:modified>
  <cp:revision>50</cp:revision>
  <dc:subject/>
  <dc:title>スライド 1</dc:title>
</cp:coreProperties>
</file>